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5" r:id="rId6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693"/>
    <p:restoredTop sz="94674"/>
  </p:normalViewPr>
  <p:slideViewPr>
    <p:cSldViewPr snapToGrid="0" snapToObjects="1">
      <p:cViewPr>
        <p:scale>
          <a:sx n="160" d="100"/>
          <a:sy n="160" d="100"/>
        </p:scale>
        <p:origin x="1448" y="-2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682A94-8C86-B842-B4F5-DBB77A9628AA}" type="datetimeFigureOut">
              <a:rPr lang="en-US" smtClean="0"/>
              <a:t>8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BC15E5-1105-0E4F-B675-C8F25602A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3724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EB87E67B-85EB-AC49-A433-9DBE79C4AE19}" type="slidenum">
              <a:rPr lang="en-US" smtClean="0"/>
              <a:pPr>
                <a:defRPr/>
              </a:pPr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528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294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616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003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933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045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53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971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922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673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834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512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D14D2-5488-134E-8DFE-1E58ECF2D428}" type="datetimeFigureOut">
              <a:rPr lang="en-US" smtClean="0"/>
              <a:t>8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D1FEC-BDA0-FA4B-BF42-BC9D819D7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506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3A96C63E-3DD4-D843-A18B-14B06DCDEBAE}"/>
              </a:ext>
            </a:extLst>
          </p:cNvPr>
          <p:cNvGrpSpPr/>
          <p:nvPr/>
        </p:nvGrpSpPr>
        <p:grpSpPr>
          <a:xfrm>
            <a:off x="563245" y="2113597"/>
            <a:ext cx="5731510" cy="3088005"/>
            <a:chOff x="563245" y="3027997"/>
            <a:chExt cx="5731510" cy="308800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9D0AE06-8F4B-A44B-AC0D-9269C7B5F344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3245" y="3027997"/>
              <a:ext cx="5731510" cy="3088005"/>
            </a:xfrm>
            <a:prstGeom prst="rect">
              <a:avLst/>
            </a:prstGeom>
          </p:spPr>
        </p:pic>
        <p:sp>
          <p:nvSpPr>
            <p:cNvPr id="6" name="Text Box 2">
              <a:extLst>
                <a:ext uri="{FF2B5EF4-FFF2-40B4-BE49-F238E27FC236}">
                  <a16:creationId xmlns:a16="http://schemas.microsoft.com/office/drawing/2014/main" id="{2F4EB9D0-D89A-3A4E-9D98-849C70C07E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55720" y="3469322"/>
              <a:ext cx="1760220" cy="38608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NZ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β-ManCer (M = 857.7 Da)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 Box 2">
              <a:extLst>
                <a:ext uri="{FF2B5EF4-FFF2-40B4-BE49-F238E27FC236}">
                  <a16:creationId xmlns:a16="http://schemas.microsoft.com/office/drawing/2014/main" id="{09026A4C-B3DA-3343-81B7-BBA77205D7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90470" y="5257482"/>
              <a:ext cx="723265" cy="38608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NZ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-28 D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 Box 2">
              <a:extLst>
                <a:ext uri="{FF2B5EF4-FFF2-40B4-BE49-F238E27FC236}">
                  <a16:creationId xmlns:a16="http://schemas.microsoft.com/office/drawing/2014/main" id="{C7927D58-2EA9-8B4B-8E4C-2B9A76C77B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28265" y="5027612"/>
              <a:ext cx="723265" cy="24638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NZ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-14 D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 Box 2">
              <a:extLst>
                <a:ext uri="{FF2B5EF4-FFF2-40B4-BE49-F238E27FC236}">
                  <a16:creationId xmlns:a16="http://schemas.microsoft.com/office/drawing/2014/main" id="{E29FBD9D-40AA-CF45-A945-17114E94E9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40200" y="5207317"/>
              <a:ext cx="723265" cy="24638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NZ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+28 D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66FFC016-C3A9-B04B-9FD0-464995368F98}"/>
                </a:ext>
              </a:extLst>
            </p:cNvPr>
            <p:cNvCxnSpPr/>
            <p:nvPr/>
          </p:nvCxnSpPr>
          <p:spPr>
            <a:xfrm>
              <a:off x="3119120" y="5415597"/>
              <a:ext cx="309880" cy="26225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DA07B16B-FD3D-2549-B14B-ADF7CF1DC9C8}"/>
                </a:ext>
              </a:extLst>
            </p:cNvPr>
            <p:cNvCxnSpPr/>
            <p:nvPr/>
          </p:nvCxnSpPr>
          <p:spPr>
            <a:xfrm flipH="1">
              <a:off x="3951605" y="5369877"/>
              <a:ext cx="238760" cy="28575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4D0E3DF6-515C-7A49-B0DE-2E0FDEA1561B}"/>
                </a:ext>
              </a:extLst>
            </p:cNvPr>
            <p:cNvCxnSpPr/>
            <p:nvPr/>
          </p:nvCxnSpPr>
          <p:spPr>
            <a:xfrm flipH="1">
              <a:off x="3718560" y="3619817"/>
              <a:ext cx="18288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36F168B2-44F5-D640-A2CF-6C5B2BDAE442}"/>
                </a:ext>
              </a:extLst>
            </p:cNvPr>
            <p:cNvCxnSpPr/>
            <p:nvPr/>
          </p:nvCxnSpPr>
          <p:spPr>
            <a:xfrm flipH="1">
              <a:off x="3789045" y="5247322"/>
              <a:ext cx="238760" cy="28575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 Box 2">
              <a:extLst>
                <a:ext uri="{FF2B5EF4-FFF2-40B4-BE49-F238E27FC236}">
                  <a16:creationId xmlns:a16="http://schemas.microsoft.com/office/drawing/2014/main" id="{92F739A5-7EF0-724A-B24B-F3A7EF5041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39540" y="5014277"/>
              <a:ext cx="723265" cy="24638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NZ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+14 D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969F7ED1-A8C2-2C4E-A99B-96D2E2EB324B}"/>
                </a:ext>
              </a:extLst>
            </p:cNvPr>
            <p:cNvCxnSpPr/>
            <p:nvPr/>
          </p:nvCxnSpPr>
          <p:spPr>
            <a:xfrm>
              <a:off x="3235325" y="5254942"/>
              <a:ext cx="309880" cy="26225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Rectangle 19">
            <a:extLst>
              <a:ext uri="{FF2B5EF4-FFF2-40B4-BE49-F238E27FC236}">
                <a16:creationId xmlns:a16="http://schemas.microsoft.com/office/drawing/2014/main" id="{B47FCA1A-0C38-8A42-BE8E-EF6A33844D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3245" y="5250486"/>
            <a:ext cx="5731510" cy="144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PLC-CAD chromatogram of β-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howing compound purity.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-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1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µ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, 0.5 mg/mL) was injected onto a </a:t>
            </a:r>
            <a:r>
              <a:rPr kumimoji="0" lang="en-NZ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enomenex</a:t>
            </a: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NZ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inetex</a:t>
            </a: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lumn (2.6 </a:t>
            </a:r>
            <a:r>
              <a:rPr kumimoji="0" lang="en-NZ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μm</a:t>
            </a: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100 </a:t>
            </a:r>
            <a:r>
              <a:rPr kumimoji="0" lang="en-NZ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Å</a:t>
            </a: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3 x 50 mm). Elution conditions; Mobile Phase A: Water + 0.1% formic acid, mobile Phase B: Methanol, gradient (A:B): T0 = 40:60, T4 = 0:100, T12 = 0:100, T13 = 40:60, T15 = 40:60, flow: 0.5 mL/min, column temperature:40 °C. </a:t>
            </a: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kumimoji="0" lang="en-NZ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s confirmed by mass spectrometry, M = 857.7) eluted at T = 7.54 min (97.3%) together with minor impurities: M-28 (T = 7.04 min, 0.30%); M-14 (T = 7.30 min, 0.39%), M+14 (T = 7.8 min, 0.20%), M+28 (8.14 min, 1.80%). </a:t>
            </a: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TextBox 92">
            <a:extLst>
              <a:ext uri="{FF2B5EF4-FFF2-40B4-BE49-F238E27FC236}">
                <a16:creationId xmlns:a16="http://schemas.microsoft.com/office/drawing/2014/main" id="{0F99E415-F7BA-B846-A0FB-BC996A8995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4934" y="168275"/>
            <a:ext cx="22352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ark et al. 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3078057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94">
            <a:extLst>
              <a:ext uri="{FF2B5EF4-FFF2-40B4-BE49-F238E27FC236}">
                <a16:creationId xmlns:a16="http://schemas.microsoft.com/office/drawing/2014/main" id="{6F65191C-C94B-BE41-840F-B311A17669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064" y="1639824"/>
            <a:ext cx="5727700" cy="4953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 Box 2">
            <a:extLst>
              <a:ext uri="{FF2B5EF4-FFF2-40B4-BE49-F238E27FC236}">
                <a16:creationId xmlns:a16="http://schemas.microsoft.com/office/drawing/2014/main" id="{C21B41FA-EB1F-B949-926D-FF95CD20EC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639" y="2160524"/>
            <a:ext cx="444500" cy="25241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NZ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D</a:t>
            </a:r>
            <a:endParaRPr kumimoji="0" lang="en-NZ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 Box 6">
            <a:extLst>
              <a:ext uri="{FF2B5EF4-FFF2-40B4-BE49-F238E27FC236}">
                <a16:creationId xmlns:a16="http://schemas.microsoft.com/office/drawing/2014/main" id="{E77DF3F5-E10A-0147-8EBD-F55449027C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7989" y="2918428"/>
            <a:ext cx="382588" cy="25241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C</a:t>
            </a: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20BFB28A-66EA-3E4A-AEC5-89B58480CF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7989" y="3607403"/>
            <a:ext cx="1543050" cy="25241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-28 EI: M = 852.7 m/z </a:t>
            </a: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 Box 3">
            <a:extLst>
              <a:ext uri="{FF2B5EF4-FFF2-40B4-BE49-F238E27FC236}">
                <a16:creationId xmlns:a16="http://schemas.microsoft.com/office/drawing/2014/main" id="{B8374849-5A80-CF42-A19A-86E16D4194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639" y="4358291"/>
            <a:ext cx="1570038" cy="25241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-14 EI: M = 866.7 m/z </a:t>
            </a: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 Box 4">
            <a:extLst>
              <a:ext uri="{FF2B5EF4-FFF2-40B4-BE49-F238E27FC236}">
                <a16:creationId xmlns:a16="http://schemas.microsoft.com/office/drawing/2014/main" id="{5468F515-1A17-6248-BD08-15B2847DDD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1002" y="5074253"/>
            <a:ext cx="1555750" cy="25241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+14 EI: M = 894.7 m/z </a:t>
            </a: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Text Box 5">
            <a:extLst>
              <a:ext uri="{FF2B5EF4-FFF2-40B4-BE49-F238E27FC236}">
                <a16:creationId xmlns:a16="http://schemas.microsoft.com/office/drawing/2014/main" id="{1580B226-7E28-4146-B1AF-1865987B31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639" y="5818791"/>
            <a:ext cx="1568450" cy="25241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NZ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+28 EI: M = 908.7 m/z </a:t>
            </a: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8">
            <a:extLst>
              <a:ext uri="{FF2B5EF4-FFF2-40B4-BE49-F238E27FC236}">
                <a16:creationId xmlns:a16="http://schemas.microsoft.com/office/drawing/2014/main" id="{7CC8B7F7-54FB-4747-A180-99A87C9CA5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2064" y="7029386"/>
            <a:ext cx="5376672" cy="1046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PLC-CAD-MS chromatograms of β-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howing the impurity profile.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-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as analyzed by HPLC chromatography (as described in Supplemental Figure 1 above). The extracted ions (EI) pertaining to sodium adducts of methylene homologues of β-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extracted from the Total Ion Current (TIC) and overlaid with the CAD trace. </a:t>
            </a:r>
            <a:endParaRPr kumimoji="0" lang="en-US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9">
            <a:extLst>
              <a:ext uri="{FF2B5EF4-FFF2-40B4-BE49-F238E27FC236}">
                <a16:creationId xmlns:a16="http://schemas.microsoft.com/office/drawing/2014/main" id="{DA9F248D-B356-B44B-8951-FF2F95B6FE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2064" y="163982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0" name="Rectangle 10">
            <a:extLst>
              <a:ext uri="{FF2B5EF4-FFF2-40B4-BE49-F238E27FC236}">
                <a16:creationId xmlns:a16="http://schemas.microsoft.com/office/drawing/2014/main" id="{F4576C39-CABA-2A45-8BA5-72FA47C40F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2064" y="659282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TextBox 92">
            <a:extLst>
              <a:ext uri="{FF2B5EF4-FFF2-40B4-BE49-F238E27FC236}">
                <a16:creationId xmlns:a16="http://schemas.microsoft.com/office/drawing/2014/main" id="{3DC3A7B6-5482-064A-B693-CA888AC674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4934" y="168275"/>
            <a:ext cx="22352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ark et al. 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11037915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7C7AF621-8607-C54B-8D58-30E9C49D0F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7136" y="5157475"/>
            <a:ext cx="4472699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US" altLang="en-US" sz="1100" b="0" i="1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1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(500 MHz, </a:t>
            </a:r>
            <a:r>
              <a:rPr kumimoji="0" lang="en-NZ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:1 CDCl</a:t>
            </a:r>
            <a:r>
              <a:rPr kumimoji="0" lang="en-NZ" altLang="en-US" sz="11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kumimoji="0" lang="en-NZ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CD</a:t>
            </a:r>
            <a:r>
              <a:rPr kumimoji="0" lang="en-NZ" altLang="en-US" sz="11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kumimoji="0" lang="en-NZ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) 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β-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– full window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3073" name="Content Placeholder 3">
            <a:extLst>
              <a:ext uri="{FF2B5EF4-FFF2-40B4-BE49-F238E27FC236}">
                <a16:creationId xmlns:a16="http://schemas.microsoft.com/office/drawing/2014/main" id="{72CEF4CB-5EC2-9D48-A029-0945212C1843}"/>
              </a:ext>
            </a:extLst>
          </p:cNvPr>
          <p:cNvPicPr>
            <a:picLocks noGrp="1"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7136" y="1883664"/>
            <a:ext cx="5727700" cy="2997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92">
            <a:extLst>
              <a:ext uri="{FF2B5EF4-FFF2-40B4-BE49-F238E27FC236}">
                <a16:creationId xmlns:a16="http://schemas.microsoft.com/office/drawing/2014/main" id="{D4E445DF-12B1-F24F-A90D-D5436250EF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4934" y="168275"/>
            <a:ext cx="22352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ark et al. Supplemental Figure 3</a:t>
            </a:r>
          </a:p>
        </p:txBody>
      </p:sp>
    </p:spTree>
    <p:extLst>
      <p:ext uri="{BB962C8B-B14F-4D97-AF65-F5344CB8AC3E}">
        <p14:creationId xmlns:p14="http://schemas.microsoft.com/office/powerpoint/2010/main" val="2155611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Picture 1">
            <a:extLst>
              <a:ext uri="{FF2B5EF4-FFF2-40B4-BE49-F238E27FC236}">
                <a16:creationId xmlns:a16="http://schemas.microsoft.com/office/drawing/2014/main" id="{4432F664-D7C0-A544-A8DF-3D7FF3493E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508" y="2304479"/>
            <a:ext cx="5730875" cy="3133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6657F219-17F7-194C-8786-863A93080A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6799" y="5683142"/>
            <a:ext cx="5815584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US" altLang="en-US" sz="1100" b="0" i="1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1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NMR (500 MHz, </a:t>
            </a:r>
            <a:r>
              <a:rPr kumimoji="0" lang="en-NZ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:1 CDCl</a:t>
            </a:r>
            <a:r>
              <a:rPr kumimoji="0" lang="en-NZ" altLang="en-US" sz="11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kumimoji="0" lang="en-NZ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CD</a:t>
            </a:r>
            <a:r>
              <a:rPr kumimoji="0" lang="en-NZ" altLang="en-US" sz="11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kumimoji="0" lang="en-NZ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) 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beta-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– expansion of 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hine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methylene region where any α-anomer would be evident. The anomeric 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hine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α-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sonates at 4.75 ppm for this solvent system (unpublished data)</a:t>
            </a:r>
            <a:r>
              <a:rPr kumimoji="0" lang="en-NZ" altLang="en-U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NZ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TextBox 92">
            <a:extLst>
              <a:ext uri="{FF2B5EF4-FFF2-40B4-BE49-F238E27FC236}">
                <a16:creationId xmlns:a16="http://schemas.microsoft.com/office/drawing/2014/main" id="{80785CF1-D25A-044B-A394-6ADE5AC81B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4934" y="168275"/>
            <a:ext cx="22352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lark et al. Supplemental Figure 4</a:t>
            </a:r>
          </a:p>
        </p:txBody>
      </p:sp>
    </p:spTree>
    <p:extLst>
      <p:ext uri="{BB962C8B-B14F-4D97-AF65-F5344CB8AC3E}">
        <p14:creationId xmlns:p14="http://schemas.microsoft.com/office/powerpoint/2010/main" val="4394771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1" name="Picture 3">
            <a:extLst>
              <a:ext uri="{FF2B5EF4-FFF2-40B4-BE49-F238E27FC236}">
                <a16:creationId xmlns:a16="http://schemas.microsoft.com/office/drawing/2014/main" id="{6FB35F0A-0474-F04B-B604-E943BB024C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8236" y="3204880"/>
            <a:ext cx="1702955" cy="12180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2" name="TextBox 92">
            <a:extLst>
              <a:ext uri="{FF2B5EF4-FFF2-40B4-BE49-F238E27FC236}">
                <a16:creationId xmlns:a16="http://schemas.microsoft.com/office/drawing/2014/main" id="{9B6559A3-0539-584D-A848-14DA05EBCB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9205" y="152978"/>
            <a:ext cx="2042547" cy="232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Clark et al. Supplemental Figure 5</a:t>
            </a:r>
          </a:p>
        </p:txBody>
      </p:sp>
      <p:pic>
        <p:nvPicPr>
          <p:cNvPr id="25603" name="Picture 5">
            <a:extLst>
              <a:ext uri="{FF2B5EF4-FFF2-40B4-BE49-F238E27FC236}">
                <a16:creationId xmlns:a16="http://schemas.microsoft.com/office/drawing/2014/main" id="{ED924997-D9F7-104B-95C3-6536BD4289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5445" y="3236206"/>
            <a:ext cx="1610591" cy="11834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4" name="TextBox 6">
            <a:extLst>
              <a:ext uri="{FF2B5EF4-FFF2-40B4-BE49-F238E27FC236}">
                <a16:creationId xmlns:a16="http://schemas.microsoft.com/office/drawing/2014/main" id="{FFB79006-6C7E-014C-9815-125E96C3C7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0754" y="4452386"/>
            <a:ext cx="1422184" cy="20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727" b="1">
                <a:latin typeface="Helvetica" pitchFamily="2" charset="0"/>
              </a:rPr>
              <a:t>Concentration of lipids (nM)</a:t>
            </a:r>
          </a:p>
        </p:txBody>
      </p:sp>
      <p:sp>
        <p:nvSpPr>
          <p:cNvPr id="25605" name="TextBox 7">
            <a:extLst>
              <a:ext uri="{FF2B5EF4-FFF2-40B4-BE49-F238E27FC236}">
                <a16:creationId xmlns:a16="http://schemas.microsoft.com/office/drawing/2014/main" id="{26721101-7DF4-E048-BC41-5409CE667A89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408695" y="3748765"/>
            <a:ext cx="686406" cy="20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727" b="1">
                <a:latin typeface="Helvetica" pitchFamily="2" charset="0"/>
              </a:rPr>
              <a:t>IL-2 (pg/ml)</a:t>
            </a:r>
          </a:p>
        </p:txBody>
      </p:sp>
      <p:pic>
        <p:nvPicPr>
          <p:cNvPr id="25606" name="Picture 9">
            <a:extLst>
              <a:ext uri="{FF2B5EF4-FFF2-40B4-BE49-F238E27FC236}">
                <a16:creationId xmlns:a16="http://schemas.microsoft.com/office/drawing/2014/main" id="{7FD8E3AF-6670-C34F-80D1-A124FB062F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0291" y="3239518"/>
            <a:ext cx="1541318" cy="11891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6">
            <a:extLst>
              <a:ext uri="{FF2B5EF4-FFF2-40B4-BE49-F238E27FC236}">
                <a16:creationId xmlns:a16="http://schemas.microsoft.com/office/drawing/2014/main" id="{8FC462EA-D8FE-404D-B143-4D97DEB5E9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7695" y="4452386"/>
            <a:ext cx="1422184" cy="20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727" b="1">
                <a:latin typeface="Helvetica" pitchFamily="2" charset="0"/>
              </a:rPr>
              <a:t>Concentration of lipids (nM)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A5DB1A3E-C95D-1E44-AFE3-A9C3B3E1C6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9224" y="4452386"/>
            <a:ext cx="1422184" cy="20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727" b="1">
                <a:latin typeface="Helvetica" pitchFamily="2" charset="0"/>
              </a:rPr>
              <a:t>Concentration of lipids (nM)</a:t>
            </a:r>
          </a:p>
        </p:txBody>
      </p:sp>
      <p:sp>
        <p:nvSpPr>
          <p:cNvPr id="10" name="TextBox 7">
            <a:extLst>
              <a:ext uri="{FF2B5EF4-FFF2-40B4-BE49-F238E27FC236}">
                <a16:creationId xmlns:a16="http://schemas.microsoft.com/office/drawing/2014/main" id="{B0EB71BB-5E66-A64D-92CE-DAD83B3FEA88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148664" y="3748765"/>
            <a:ext cx="686406" cy="20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727" b="1">
                <a:latin typeface="Helvetica" pitchFamily="2" charset="0"/>
              </a:rPr>
              <a:t>IL-2 (pg/ml)</a:t>
            </a:r>
          </a:p>
        </p:txBody>
      </p:sp>
      <p:sp>
        <p:nvSpPr>
          <p:cNvPr id="11" name="TextBox 7">
            <a:extLst>
              <a:ext uri="{FF2B5EF4-FFF2-40B4-BE49-F238E27FC236}">
                <a16:creationId xmlns:a16="http://schemas.microsoft.com/office/drawing/2014/main" id="{7A34497C-39DD-FF4C-BBD5-8237A759E094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3827508" y="3748765"/>
            <a:ext cx="686406" cy="204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727" b="1">
                <a:latin typeface="Helvetica" pitchFamily="2" charset="0"/>
              </a:rPr>
              <a:t>IL-2 (pg/ml)</a:t>
            </a:r>
          </a:p>
        </p:txBody>
      </p:sp>
      <p:sp>
        <p:nvSpPr>
          <p:cNvPr id="12" name="Rectangle 3">
            <a:extLst>
              <a:ext uri="{FF2B5EF4-FFF2-40B4-BE49-F238E27FC236}">
                <a16:creationId xmlns:a16="http://schemas.microsoft.com/office/drawing/2014/main" id="{F7EDEC87-AAF1-2146-9CB8-A66D7A5E35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0772" y="4868742"/>
            <a:ext cx="5286895" cy="6994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3127" tIns="41564" rIns="83127" bIns="41564" numCol="1" anchor="ctr" anchorCtr="0" compatLnSpc="1">
            <a:prstTxWarp prst="textNoShape">
              <a:avLst/>
            </a:prstTxWarp>
            <a:spAutoFit/>
          </a:bodyPr>
          <a:lstStyle/>
          <a:p>
            <a:pPr lvl="0"/>
            <a:r>
              <a:rPr lang="en-US" altLang="en-US" sz="1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</a:t>
            </a:r>
            <a:r>
              <a:rPr lang="en-US" alt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altLang="en-US" sz="1000" i="1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NZ" altLang="en-US" sz="1000" i="1" dirty="0"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NZ" altLang="en-US" sz="10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iNKT</a:t>
            </a:r>
            <a:r>
              <a:rPr lang="en-NZ" altLang="en-US" sz="1000" i="1" dirty="0">
                <a:ea typeface="Calibri" panose="020F0502020204030204" pitchFamily="34" charset="0"/>
                <a:cs typeface="Times New Roman" panose="02020603050405020304" pitchFamily="18" charset="0"/>
              </a:rPr>
              <a:t> cell hybridoma clones DN32.D3, 24.9E, and 24.8A were stimulated for 24 hours with T cell-depleted splenocytes loaded with </a:t>
            </a:r>
            <a:r>
              <a:rPr lang="el-GR" altLang="en-US" sz="1000" i="1" dirty="0">
                <a:ea typeface="Calibri" panose="020F0502020204030204" pitchFamily="34" charset="0"/>
                <a:cs typeface="Times New Roman" panose="02020603050405020304" pitchFamily="18" charset="0"/>
              </a:rPr>
              <a:t>α-</a:t>
            </a:r>
            <a:r>
              <a:rPr lang="en-NZ" altLang="en-US" sz="10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GalCer</a:t>
            </a:r>
            <a:r>
              <a:rPr lang="en-NZ" altLang="en-US" sz="1000" i="1" dirty="0">
                <a:ea typeface="Calibri" panose="020F0502020204030204" pitchFamily="34" charset="0"/>
                <a:cs typeface="Times New Roman" panose="02020603050405020304" pitchFamily="18" charset="0"/>
              </a:rPr>
              <a:t> or </a:t>
            </a:r>
            <a:r>
              <a:rPr lang="el-GR" altLang="en-US" sz="1000" i="1" dirty="0">
                <a:ea typeface="Calibri" panose="020F0502020204030204" pitchFamily="34" charset="0"/>
                <a:cs typeface="Times New Roman" panose="02020603050405020304" pitchFamily="18" charset="0"/>
              </a:rPr>
              <a:t>β-</a:t>
            </a:r>
            <a:r>
              <a:rPr lang="en-NZ" altLang="en-US" sz="1000" i="1" dirty="0" err="1">
                <a:ea typeface="Calibri" panose="020F0502020204030204" pitchFamily="34" charset="0"/>
                <a:cs typeface="Times New Roman" panose="02020603050405020304" pitchFamily="18" charset="0"/>
              </a:rPr>
              <a:t>ManCer</a:t>
            </a:r>
            <a:r>
              <a:rPr lang="en-NZ" altLang="en-US" sz="1000" i="1" dirty="0">
                <a:ea typeface="Calibri" panose="020F0502020204030204" pitchFamily="34" charset="0"/>
                <a:cs typeface="Times New Roman" panose="02020603050405020304" pitchFamily="18" charset="0"/>
              </a:rPr>
              <a:t>, and IL-2 concentrations in the supernatant were determined by ELISA. Data are plotted as mean + SD of triplicates. Representative experiments of 2 independent repeats are shown.</a:t>
            </a:r>
            <a:endParaRPr lang="en-NZ" altLang="en-US" sz="1636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652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6</TotalTime>
  <Words>486</Words>
  <Application>Microsoft Macintosh PowerPoint</Application>
  <PresentationFormat>Letter Paper (8.5x11 in)</PresentationFormat>
  <Paragraphs>3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Terabe, Masaki (NIH/NCI) [E]</cp:lastModifiedBy>
  <cp:revision>10</cp:revision>
  <dcterms:created xsi:type="dcterms:W3CDTF">2018-07-30T12:16:11Z</dcterms:created>
  <dcterms:modified xsi:type="dcterms:W3CDTF">2019-08-26T19:10:15Z</dcterms:modified>
</cp:coreProperties>
</file>